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99" d="100"/>
          <a:sy n="99" d="100"/>
        </p:scale>
        <p:origin x="934" y="4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ioAdmin\Documents\Writing\oo%20ZWRI%20tomato%20study\chromoplast%20fraction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ioAdmin\Documents\Writing\oo%20ZWRI%20tomato%20study\chromoplast%20fraction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chromoplast fractionation.xlsx]ZW0RI3'!$D$38</c:f>
              <c:strCache>
                <c:ptCount val="1"/>
                <c:pt idx="0">
                  <c:v>Cyclic carotenoids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[chromoplast fractionation.xlsx]ZW0RI3'!$E$29:$AF$29</c:f>
              <c:strCache>
                <c:ptCount val="28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  <c:pt idx="10">
                  <c:v>F11</c:v>
                </c:pt>
                <c:pt idx="11">
                  <c:v>F12</c:v>
                </c:pt>
                <c:pt idx="12">
                  <c:v>F13</c:v>
                </c:pt>
                <c:pt idx="13">
                  <c:v>F14</c:v>
                </c:pt>
                <c:pt idx="14">
                  <c:v>F15</c:v>
                </c:pt>
                <c:pt idx="15">
                  <c:v>F16</c:v>
                </c:pt>
                <c:pt idx="16">
                  <c:v>F17</c:v>
                </c:pt>
                <c:pt idx="17">
                  <c:v>F18</c:v>
                </c:pt>
                <c:pt idx="18">
                  <c:v>F19</c:v>
                </c:pt>
                <c:pt idx="19">
                  <c:v>F20</c:v>
                </c:pt>
                <c:pt idx="20">
                  <c:v>F21</c:v>
                </c:pt>
                <c:pt idx="21">
                  <c:v>F22</c:v>
                </c:pt>
                <c:pt idx="22">
                  <c:v>F23</c:v>
                </c:pt>
                <c:pt idx="23">
                  <c:v>F24</c:v>
                </c:pt>
                <c:pt idx="24">
                  <c:v>F25</c:v>
                </c:pt>
                <c:pt idx="25">
                  <c:v>F26</c:v>
                </c:pt>
                <c:pt idx="26">
                  <c:v>F27</c:v>
                </c:pt>
                <c:pt idx="27">
                  <c:v>F28</c:v>
                </c:pt>
              </c:strCache>
            </c:strRef>
          </c:cat>
          <c:val>
            <c:numRef>
              <c:f>'[chromoplast fractionation.xlsx]ZW0RI3'!$E$38:$AF$38</c:f>
              <c:numCache>
                <c:formatCode>0.0</c:formatCode>
                <c:ptCount val="28"/>
                <c:pt idx="0">
                  <c:v>1.9000498757616451</c:v>
                </c:pt>
                <c:pt idx="1">
                  <c:v>2.5054607534628941</c:v>
                </c:pt>
                <c:pt idx="2">
                  <c:v>3.4805649267017706</c:v>
                </c:pt>
                <c:pt idx="3">
                  <c:v>3.5779846050881932</c:v>
                </c:pt>
                <c:pt idx="4">
                  <c:v>3.557226923305036</c:v>
                </c:pt>
                <c:pt idx="5">
                  <c:v>3.5308002598932475</c:v>
                </c:pt>
                <c:pt idx="6">
                  <c:v>3.4326881774040974</c:v>
                </c:pt>
                <c:pt idx="7">
                  <c:v>3.2743461974245793</c:v>
                </c:pt>
                <c:pt idx="8">
                  <c:v>2.9313660372820025</c:v>
                </c:pt>
                <c:pt idx="9">
                  <c:v>2.6262052662595079</c:v>
                </c:pt>
                <c:pt idx="10">
                  <c:v>2.8507263168365085</c:v>
                </c:pt>
                <c:pt idx="11">
                  <c:v>2.8503817985646238</c:v>
                </c:pt>
                <c:pt idx="12">
                  <c:v>2.8814487933409403</c:v>
                </c:pt>
                <c:pt idx="13">
                  <c:v>2.863186592067438</c:v>
                </c:pt>
                <c:pt idx="14">
                  <c:v>3.6848878839952142</c:v>
                </c:pt>
                <c:pt idx="15">
                  <c:v>3.8805948641675969</c:v>
                </c:pt>
                <c:pt idx="16">
                  <c:v>5.1097973949201654</c:v>
                </c:pt>
                <c:pt idx="17">
                  <c:v>16.207394899417817</c:v>
                </c:pt>
                <c:pt idx="18">
                  <c:v>6.6591535244239157</c:v>
                </c:pt>
                <c:pt idx="19">
                  <c:v>3.2879107443218873</c:v>
                </c:pt>
                <c:pt idx="20">
                  <c:v>2.7022704383015794</c:v>
                </c:pt>
                <c:pt idx="21">
                  <c:v>2.5776481883557651</c:v>
                </c:pt>
                <c:pt idx="22">
                  <c:v>2.3142317365977108</c:v>
                </c:pt>
                <c:pt idx="23">
                  <c:v>2.2558619449832324</c:v>
                </c:pt>
                <c:pt idx="24">
                  <c:v>2.2256511834165273</c:v>
                </c:pt>
                <c:pt idx="25">
                  <c:v>2.1765038479425063</c:v>
                </c:pt>
                <c:pt idx="26">
                  <c:v>2.188857031006795</c:v>
                </c:pt>
                <c:pt idx="27">
                  <c:v>2.466799794756807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1CF-4448-8B0C-F759111437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59645136"/>
        <c:axId val="360226400"/>
      </c:lineChart>
      <c:catAx>
        <c:axId val="359645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226400"/>
        <c:crosses val="autoZero"/>
        <c:auto val="1"/>
        <c:lblAlgn val="ctr"/>
        <c:lblOffset val="100"/>
        <c:noMultiLvlLbl val="0"/>
      </c:catAx>
      <c:valAx>
        <c:axId val="360226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9645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chromoplast fractionation.xlsx]ZW0RI07'!$D$28</c:f>
              <c:strCache>
                <c:ptCount val="1"/>
                <c:pt idx="0">
                  <c:v>Cyclic carotenoids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[chromoplast fractionation.xlsx]ZW0RI07'!$E$21:$AF$21</c:f>
              <c:strCache>
                <c:ptCount val="28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  <c:pt idx="10">
                  <c:v>F11</c:v>
                </c:pt>
                <c:pt idx="11">
                  <c:v>F12</c:v>
                </c:pt>
                <c:pt idx="12">
                  <c:v>F13</c:v>
                </c:pt>
                <c:pt idx="13">
                  <c:v>F14</c:v>
                </c:pt>
                <c:pt idx="14">
                  <c:v>F15</c:v>
                </c:pt>
                <c:pt idx="15">
                  <c:v>F16</c:v>
                </c:pt>
                <c:pt idx="16">
                  <c:v>F17</c:v>
                </c:pt>
                <c:pt idx="17">
                  <c:v>F18</c:v>
                </c:pt>
                <c:pt idx="18">
                  <c:v>F19</c:v>
                </c:pt>
                <c:pt idx="19">
                  <c:v>F20</c:v>
                </c:pt>
                <c:pt idx="20">
                  <c:v>F21</c:v>
                </c:pt>
                <c:pt idx="21">
                  <c:v>F22</c:v>
                </c:pt>
                <c:pt idx="22">
                  <c:v>F23</c:v>
                </c:pt>
                <c:pt idx="23">
                  <c:v>F24</c:v>
                </c:pt>
                <c:pt idx="24">
                  <c:v>F25</c:v>
                </c:pt>
                <c:pt idx="25">
                  <c:v>F26</c:v>
                </c:pt>
                <c:pt idx="26">
                  <c:v>F27</c:v>
                </c:pt>
                <c:pt idx="27">
                  <c:v>F28</c:v>
                </c:pt>
              </c:strCache>
            </c:strRef>
          </c:cat>
          <c:val>
            <c:numRef>
              <c:f>'[chromoplast fractionation.xlsx]ZW0RI07'!$E$28:$AF$28</c:f>
              <c:numCache>
                <c:formatCode>0.0</c:formatCode>
                <c:ptCount val="28"/>
                <c:pt idx="0">
                  <c:v>3.4690167860705916</c:v>
                </c:pt>
                <c:pt idx="1">
                  <c:v>3.4050376959216599</c:v>
                </c:pt>
                <c:pt idx="2">
                  <c:v>3.3559133412602029</c:v>
                </c:pt>
                <c:pt idx="3">
                  <c:v>3.4013832079026343</c:v>
                </c:pt>
                <c:pt idx="4">
                  <c:v>3.3570952403599743</c:v>
                </c:pt>
                <c:pt idx="5">
                  <c:v>3.3839922086941194</c:v>
                </c:pt>
                <c:pt idx="6">
                  <c:v>3.3690289049520161</c:v>
                </c:pt>
                <c:pt idx="7">
                  <c:v>3.3819922359225427</c:v>
                </c:pt>
                <c:pt idx="8">
                  <c:v>3.3280889261263553</c:v>
                </c:pt>
                <c:pt idx="9">
                  <c:v>3.2988326670507764</c:v>
                </c:pt>
                <c:pt idx="10">
                  <c:v>3.3188772105120923</c:v>
                </c:pt>
                <c:pt idx="11">
                  <c:v>3.3018807970751212</c:v>
                </c:pt>
                <c:pt idx="12">
                  <c:v>3.32767230127997</c:v>
                </c:pt>
                <c:pt idx="13">
                  <c:v>3.3696739715595574</c:v>
                </c:pt>
                <c:pt idx="14">
                  <c:v>3.5365271484764942</c:v>
                </c:pt>
                <c:pt idx="15">
                  <c:v>3.7556447849781347</c:v>
                </c:pt>
                <c:pt idx="16">
                  <c:v>4.5005136080818664</c:v>
                </c:pt>
                <c:pt idx="17">
                  <c:v>5.8000458238799038</c:v>
                </c:pt>
                <c:pt idx="18">
                  <c:v>4.0195392707320972</c:v>
                </c:pt>
                <c:pt idx="19">
                  <c:v>3.8195667103495068</c:v>
                </c:pt>
                <c:pt idx="20">
                  <c:v>3.7156837787517909</c:v>
                </c:pt>
                <c:pt idx="21">
                  <c:v>3.5086083293921315</c:v>
                </c:pt>
                <c:pt idx="22">
                  <c:v>3.4945138376431895</c:v>
                </c:pt>
                <c:pt idx="23">
                  <c:v>3.3882539175566171</c:v>
                </c:pt>
                <c:pt idx="24">
                  <c:v>3.3901112287579438</c:v>
                </c:pt>
                <c:pt idx="25">
                  <c:v>3.375303205175745</c:v>
                </c:pt>
                <c:pt idx="26">
                  <c:v>3.3114930656232957</c:v>
                </c:pt>
                <c:pt idx="27">
                  <c:v>3.31570979591368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98E-4CF0-BB6A-EE05454CA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94224664"/>
        <c:axId val="394225048"/>
      </c:lineChart>
      <c:catAx>
        <c:axId val="394224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225048"/>
        <c:crosses val="autoZero"/>
        <c:auto val="1"/>
        <c:lblAlgn val="ctr"/>
        <c:lblOffset val="100"/>
        <c:noMultiLvlLbl val="0"/>
      </c:catAx>
      <c:valAx>
        <c:axId val="394225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224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chromoplast fractionation.xlsx]ZWRI'!$B$51</c:f>
              <c:strCache>
                <c:ptCount val="1"/>
                <c:pt idx="0">
                  <c:v>Free ketocarotenoids</c:v>
                </c:pt>
              </c:strCache>
            </c:strRef>
          </c:tx>
          <c:spPr>
            <a:ln w="2540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chromoplast fractionation.xlsx]ZWRI'!$C$38:$AD$38</c:f>
              <c:strCache>
                <c:ptCount val="28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  <c:pt idx="10">
                  <c:v>F11</c:v>
                </c:pt>
                <c:pt idx="11">
                  <c:v>F12</c:v>
                </c:pt>
                <c:pt idx="12">
                  <c:v>F13</c:v>
                </c:pt>
                <c:pt idx="13">
                  <c:v>F14</c:v>
                </c:pt>
                <c:pt idx="14">
                  <c:v>F15</c:v>
                </c:pt>
                <c:pt idx="15">
                  <c:v>F16</c:v>
                </c:pt>
                <c:pt idx="16">
                  <c:v>F17</c:v>
                </c:pt>
                <c:pt idx="17">
                  <c:v>F18</c:v>
                </c:pt>
                <c:pt idx="18">
                  <c:v>F19</c:v>
                </c:pt>
                <c:pt idx="19">
                  <c:v>F20</c:v>
                </c:pt>
                <c:pt idx="20">
                  <c:v>F21</c:v>
                </c:pt>
                <c:pt idx="21">
                  <c:v>F22</c:v>
                </c:pt>
                <c:pt idx="22">
                  <c:v>F23</c:v>
                </c:pt>
                <c:pt idx="23">
                  <c:v>F24</c:v>
                </c:pt>
                <c:pt idx="24">
                  <c:v>F25</c:v>
                </c:pt>
                <c:pt idx="25">
                  <c:v>F26</c:v>
                </c:pt>
                <c:pt idx="26">
                  <c:v>F27</c:v>
                </c:pt>
                <c:pt idx="27">
                  <c:v>F28</c:v>
                </c:pt>
              </c:strCache>
            </c:strRef>
          </c:cat>
          <c:val>
            <c:numRef>
              <c:f>'[chromoplast fractionation.xlsx]ZWRI'!$C$51:$AD$51</c:f>
              <c:numCache>
                <c:formatCode>0.0</c:formatCode>
                <c:ptCount val="28"/>
                <c:pt idx="0">
                  <c:v>4.740004673268766</c:v>
                </c:pt>
                <c:pt idx="1">
                  <c:v>2.4822880405608778</c:v>
                </c:pt>
                <c:pt idx="2">
                  <c:v>2.5584106386317305</c:v>
                </c:pt>
                <c:pt idx="3">
                  <c:v>2.4543369611037131</c:v>
                </c:pt>
                <c:pt idx="4">
                  <c:v>2.1165447317161639</c:v>
                </c:pt>
                <c:pt idx="5">
                  <c:v>1.6270361411269063</c:v>
                </c:pt>
                <c:pt idx="6">
                  <c:v>1.7118333066964235</c:v>
                </c:pt>
                <c:pt idx="7">
                  <c:v>1.6135473603502779</c:v>
                </c:pt>
                <c:pt idx="8">
                  <c:v>2.0435224220508368</c:v>
                </c:pt>
                <c:pt idx="9">
                  <c:v>1.270137700501079</c:v>
                </c:pt>
                <c:pt idx="10">
                  <c:v>1.6655910086934766</c:v>
                </c:pt>
                <c:pt idx="11">
                  <c:v>1.8974545619912391</c:v>
                </c:pt>
                <c:pt idx="12">
                  <c:v>2.418749125586086</c:v>
                </c:pt>
                <c:pt idx="13">
                  <c:v>3.5222193894133524</c:v>
                </c:pt>
                <c:pt idx="14">
                  <c:v>5.1577421146779621</c:v>
                </c:pt>
                <c:pt idx="15">
                  <c:v>5.490123567470877</c:v>
                </c:pt>
                <c:pt idx="16">
                  <c:v>14.785513954334828</c:v>
                </c:pt>
                <c:pt idx="17">
                  <c:v>28.402306161069081</c:v>
                </c:pt>
                <c:pt idx="18">
                  <c:v>5.0129308440708114</c:v>
                </c:pt>
                <c:pt idx="19">
                  <c:v>2.7354795664653837</c:v>
                </c:pt>
                <c:pt idx="20">
                  <c:v>1.8134638019876217</c:v>
                </c:pt>
                <c:pt idx="21">
                  <c:v>0.99960985050647277</c:v>
                </c:pt>
                <c:pt idx="22">
                  <c:v>0.78225003397496773</c:v>
                </c:pt>
                <c:pt idx="23">
                  <c:v>0.48976709765161941</c:v>
                </c:pt>
                <c:pt idx="24">
                  <c:v>0.50037800312109193</c:v>
                </c:pt>
                <c:pt idx="25">
                  <c:v>0.43865469452687234</c:v>
                </c:pt>
                <c:pt idx="26">
                  <c:v>0.47147322646575812</c:v>
                </c:pt>
                <c:pt idx="27">
                  <c:v>0.798631021985714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8A3-4B7B-920A-F4A0BC65A30F}"/>
            </c:ext>
          </c:extLst>
        </c:ser>
        <c:ser>
          <c:idx val="1"/>
          <c:order val="1"/>
          <c:tx>
            <c:strRef>
              <c:f>'[chromoplast fractionation.xlsx]ZWRI'!$B$52</c:f>
              <c:strCache>
                <c:ptCount val="1"/>
                <c:pt idx="0">
                  <c:v>Ketocartenoid esters</c:v>
                </c:pt>
              </c:strCache>
            </c:strRef>
          </c:tx>
          <c:spPr>
            <a:ln w="2540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strRef>
              <c:f>'[chromoplast fractionation.xlsx]ZWRI'!$C$38:$AD$38</c:f>
              <c:strCache>
                <c:ptCount val="28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  <c:pt idx="10">
                  <c:v>F11</c:v>
                </c:pt>
                <c:pt idx="11">
                  <c:v>F12</c:v>
                </c:pt>
                <c:pt idx="12">
                  <c:v>F13</c:v>
                </c:pt>
                <c:pt idx="13">
                  <c:v>F14</c:v>
                </c:pt>
                <c:pt idx="14">
                  <c:v>F15</c:v>
                </c:pt>
                <c:pt idx="15">
                  <c:v>F16</c:v>
                </c:pt>
                <c:pt idx="16">
                  <c:v>F17</c:v>
                </c:pt>
                <c:pt idx="17">
                  <c:v>F18</c:v>
                </c:pt>
                <c:pt idx="18">
                  <c:v>F19</c:v>
                </c:pt>
                <c:pt idx="19">
                  <c:v>F20</c:v>
                </c:pt>
                <c:pt idx="20">
                  <c:v>F21</c:v>
                </c:pt>
                <c:pt idx="21">
                  <c:v>F22</c:v>
                </c:pt>
                <c:pt idx="22">
                  <c:v>F23</c:v>
                </c:pt>
                <c:pt idx="23">
                  <c:v>F24</c:v>
                </c:pt>
                <c:pt idx="24">
                  <c:v>F25</c:v>
                </c:pt>
                <c:pt idx="25">
                  <c:v>F26</c:v>
                </c:pt>
                <c:pt idx="26">
                  <c:v>F27</c:v>
                </c:pt>
                <c:pt idx="27">
                  <c:v>F28</c:v>
                </c:pt>
              </c:strCache>
            </c:strRef>
          </c:cat>
          <c:val>
            <c:numRef>
              <c:f>'[chromoplast fractionation.xlsx]ZWRI'!$C$52:$AD$52</c:f>
              <c:numCache>
                <c:formatCode>0.0</c:formatCode>
                <c:ptCount val="28"/>
                <c:pt idx="0">
                  <c:v>5.2192813939787328</c:v>
                </c:pt>
                <c:pt idx="1">
                  <c:v>2.4086756463591308</c:v>
                </c:pt>
                <c:pt idx="2">
                  <c:v>2.4266725189670453</c:v>
                </c:pt>
                <c:pt idx="3">
                  <c:v>2.1675687027456316</c:v>
                </c:pt>
                <c:pt idx="4">
                  <c:v>1.782294560945763</c:v>
                </c:pt>
                <c:pt idx="5">
                  <c:v>0.93531706245610935</c:v>
                </c:pt>
                <c:pt idx="6">
                  <c:v>1.115106220501459</c:v>
                </c:pt>
                <c:pt idx="7">
                  <c:v>1.0885280264691328</c:v>
                </c:pt>
                <c:pt idx="8">
                  <c:v>1.5758661001705332</c:v>
                </c:pt>
                <c:pt idx="9">
                  <c:v>0.53877455574594724</c:v>
                </c:pt>
                <c:pt idx="10">
                  <c:v>0.94361923888121757</c:v>
                </c:pt>
                <c:pt idx="11">
                  <c:v>1.2182774929790132</c:v>
                </c:pt>
                <c:pt idx="12">
                  <c:v>1.889109296878938</c:v>
                </c:pt>
                <c:pt idx="13">
                  <c:v>3.0808088755217522</c:v>
                </c:pt>
                <c:pt idx="14">
                  <c:v>5.0403342925669286</c:v>
                </c:pt>
                <c:pt idx="15">
                  <c:v>5.1668007122623143</c:v>
                </c:pt>
                <c:pt idx="16">
                  <c:v>15.929428589955538</c:v>
                </c:pt>
                <c:pt idx="17">
                  <c:v>35.718769103179831</c:v>
                </c:pt>
                <c:pt idx="18">
                  <c:v>5.9909369324204533</c:v>
                </c:pt>
                <c:pt idx="19">
                  <c:v>2.8527315935287958</c:v>
                </c:pt>
                <c:pt idx="20">
                  <c:v>1.2888490308486527</c:v>
                </c:pt>
                <c:pt idx="21">
                  <c:v>0.40444140363267383</c:v>
                </c:pt>
                <c:pt idx="22">
                  <c:v>0.268042873883646</c:v>
                </c:pt>
                <c:pt idx="23">
                  <c:v>0.15949601020976376</c:v>
                </c:pt>
                <c:pt idx="24">
                  <c:v>0.16102111243390352</c:v>
                </c:pt>
                <c:pt idx="25">
                  <c:v>0.15061264319019285</c:v>
                </c:pt>
                <c:pt idx="26">
                  <c:v>0.23900336443384992</c:v>
                </c:pt>
                <c:pt idx="27">
                  <c:v>0.2396326448530391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8A3-4B7B-920A-F4A0BC65A30F}"/>
            </c:ext>
          </c:extLst>
        </c:ser>
        <c:ser>
          <c:idx val="2"/>
          <c:order val="2"/>
          <c:tx>
            <c:strRef>
              <c:f>'[chromoplast fractionation.xlsx]ZWRI'!$B$53</c:f>
              <c:strCache>
                <c:ptCount val="1"/>
                <c:pt idx="0">
                  <c:v>Carotenoids</c:v>
                </c:pt>
              </c:strCache>
            </c:strRef>
          </c:tx>
          <c:spPr>
            <a:ln w="25400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[chromoplast fractionation.xlsx]ZWRI'!$C$38:$AD$38</c:f>
              <c:strCache>
                <c:ptCount val="28"/>
                <c:pt idx="0">
                  <c:v>F1</c:v>
                </c:pt>
                <c:pt idx="1">
                  <c:v>F2</c:v>
                </c:pt>
                <c:pt idx="2">
                  <c:v>F3</c:v>
                </c:pt>
                <c:pt idx="3">
                  <c:v>F4</c:v>
                </c:pt>
                <c:pt idx="4">
                  <c:v>F5</c:v>
                </c:pt>
                <c:pt idx="5">
                  <c:v>F6</c:v>
                </c:pt>
                <c:pt idx="6">
                  <c:v>F7</c:v>
                </c:pt>
                <c:pt idx="7">
                  <c:v>F8</c:v>
                </c:pt>
                <c:pt idx="8">
                  <c:v>F9</c:v>
                </c:pt>
                <c:pt idx="9">
                  <c:v>F10</c:v>
                </c:pt>
                <c:pt idx="10">
                  <c:v>F11</c:v>
                </c:pt>
                <c:pt idx="11">
                  <c:v>F12</c:v>
                </c:pt>
                <c:pt idx="12">
                  <c:v>F13</c:v>
                </c:pt>
                <c:pt idx="13">
                  <c:v>F14</c:v>
                </c:pt>
                <c:pt idx="14">
                  <c:v>F15</c:v>
                </c:pt>
                <c:pt idx="15">
                  <c:v>F16</c:v>
                </c:pt>
                <c:pt idx="16">
                  <c:v>F17</c:v>
                </c:pt>
                <c:pt idx="17">
                  <c:v>F18</c:v>
                </c:pt>
                <c:pt idx="18">
                  <c:v>F19</c:v>
                </c:pt>
                <c:pt idx="19">
                  <c:v>F20</c:v>
                </c:pt>
                <c:pt idx="20">
                  <c:v>F21</c:v>
                </c:pt>
                <c:pt idx="21">
                  <c:v>F22</c:v>
                </c:pt>
                <c:pt idx="22">
                  <c:v>F23</c:v>
                </c:pt>
                <c:pt idx="23">
                  <c:v>F24</c:v>
                </c:pt>
                <c:pt idx="24">
                  <c:v>F25</c:v>
                </c:pt>
                <c:pt idx="25">
                  <c:v>F26</c:v>
                </c:pt>
                <c:pt idx="26">
                  <c:v>F27</c:v>
                </c:pt>
                <c:pt idx="27">
                  <c:v>F28</c:v>
                </c:pt>
              </c:strCache>
            </c:strRef>
          </c:cat>
          <c:val>
            <c:numRef>
              <c:f>'[chromoplast fractionation.xlsx]ZWRI'!$C$53:$AD$53</c:f>
              <c:numCache>
                <c:formatCode>0.0</c:formatCode>
                <c:ptCount val="28"/>
                <c:pt idx="0">
                  <c:v>2.5840919242311653</c:v>
                </c:pt>
                <c:pt idx="1">
                  <c:v>2.6955403289019326</c:v>
                </c:pt>
                <c:pt idx="2">
                  <c:v>2.7392805885648017</c:v>
                </c:pt>
                <c:pt idx="3">
                  <c:v>2.9189407258097591</c:v>
                </c:pt>
                <c:pt idx="4">
                  <c:v>2.9855882995380862</c:v>
                </c:pt>
                <c:pt idx="5">
                  <c:v>2.5083319463042328</c:v>
                </c:pt>
                <c:pt idx="6">
                  <c:v>2.5738938859644152</c:v>
                </c:pt>
                <c:pt idx="7">
                  <c:v>2.4990044378213607</c:v>
                </c:pt>
                <c:pt idx="8">
                  <c:v>2.7171316109774195</c:v>
                </c:pt>
                <c:pt idx="9">
                  <c:v>2.3840377722817903</c:v>
                </c:pt>
                <c:pt idx="10">
                  <c:v>2.6091478530932704</c:v>
                </c:pt>
                <c:pt idx="11">
                  <c:v>2.7836730264207685</c:v>
                </c:pt>
                <c:pt idx="12">
                  <c:v>3.0832350804938722</c:v>
                </c:pt>
                <c:pt idx="13">
                  <c:v>3.5256419286338079</c:v>
                </c:pt>
                <c:pt idx="14">
                  <c:v>4.304590107804132</c:v>
                </c:pt>
                <c:pt idx="15">
                  <c:v>3.9921729823279946</c:v>
                </c:pt>
                <c:pt idx="16">
                  <c:v>10.187811394158061</c:v>
                </c:pt>
                <c:pt idx="17">
                  <c:v>18.811186114681991</c:v>
                </c:pt>
                <c:pt idx="18">
                  <c:v>4.2352444946078567</c:v>
                </c:pt>
                <c:pt idx="19">
                  <c:v>3.1904216037361257</c:v>
                </c:pt>
                <c:pt idx="20">
                  <c:v>2.3294709001447491</c:v>
                </c:pt>
                <c:pt idx="21">
                  <c:v>2.2103907539585568</c:v>
                </c:pt>
                <c:pt idx="22">
                  <c:v>2.093346928747235</c:v>
                </c:pt>
                <c:pt idx="23">
                  <c:v>1.9783825303069813</c:v>
                </c:pt>
                <c:pt idx="24">
                  <c:v>1.9745808578571289</c:v>
                </c:pt>
                <c:pt idx="25">
                  <c:v>1.9607218543637348</c:v>
                </c:pt>
                <c:pt idx="26">
                  <c:v>2.1179803032925846</c:v>
                </c:pt>
                <c:pt idx="27">
                  <c:v>2.00615976497619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8A3-4B7B-920A-F4A0BC65A3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94734032"/>
        <c:axId val="394226288"/>
      </c:lineChart>
      <c:catAx>
        <c:axId val="394734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226288"/>
        <c:crosses val="autoZero"/>
        <c:auto val="1"/>
        <c:lblAlgn val="ctr"/>
        <c:lblOffset val="100"/>
        <c:noMultiLvlLbl val="0"/>
      </c:catAx>
      <c:valAx>
        <c:axId val="394226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4734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E134C57-1042-43BF-97D7-FC778FAA49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4D74DB0A-501A-49E7-84BB-13AE1A4053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421F6F1-F60E-43AC-922E-C2BCEB9AF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B7B5DD4-4694-4D73-8136-8139A2E19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59AAD69-3AFB-48B5-81DC-AAC42EDCE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0725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5A1AA5F-5A15-4868-912B-C3ED7F68BC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FF5F6B5-7ECD-4C1C-8ED8-1E8574F275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A2DEB94-39C3-4B12-A48E-EC6946DC2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5AE2B86-6758-476C-9002-4E191A4CE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3772A25-466F-4107-9E61-8A56E2913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455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2E8B3C84-BE85-49F8-AC98-FEE0DD0AEB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F33867D-CAD6-4C5B-BB85-F512BA510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E2C3F58-62BD-44C3-BA3E-9DEB501EB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3C62115-DD13-4F52-821F-8F93ED8E0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A669061-ABEC-4EBE-B5D6-B57CF136A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8755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A3D76C0-EC81-4B92-B9FB-7F7FB12D73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26193F5-E4EF-4887-9D1A-6D7A2575B1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DDBC123-2BCC-4C88-83BD-EEB4130F7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CB84120-2EE1-4C5F-B6DD-935698139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08A1D0-0434-409D-922F-17893E775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38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5CC9800-05A8-4C15-A3C0-0C2034BF7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470CDB6-34D4-4EF8-867C-B64B13DE5D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622862D-360E-4DC5-87F2-EADB93500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582533B-A395-4DE4-96B1-7BFD63013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6670BBB-D2F1-47C2-92A6-D2090EF42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4768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7D9B363-8F9E-4D7A-96D3-32B62008A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99EEA010-DF35-412A-82F6-B56BC6C7B7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0F4C3FB7-BE2E-48A0-BE5A-9396CBD798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D3A1FDF-CD4E-4729-BDBD-89684C733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5B3C978-1885-4B22-A555-343EBAA1A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E49FE6C-AE92-415C-A669-7EE2AFB50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332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E3A5F4F-67E5-4251-A2C6-E98CFA785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76EC2CE-347B-4FB6-A92B-30551E23A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7AD95A3-E340-4269-9C39-238EA55D07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2884962F-EFBE-443C-9B87-1EF0265E36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1C68E956-2EF7-41D0-9CE1-C82F0E65F2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DFA39BA9-3805-4317-AE79-AC3391B30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826061BF-E9D0-4A7F-A020-A90B176B6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8913B201-D48D-4F8E-90A4-2A4913B44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827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6D6FADA-C300-4DC5-8E12-D62EF167FD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B1AD67AB-962B-4D90-889B-689B34B31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A59B2506-2A2E-4BFD-AA14-B53AB9724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7D22152A-BF62-4C38-A23D-C1E09D9F7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389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D6F721C2-B674-41FA-8D90-EF23CB215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B70BFAFF-7E3F-4CBA-9131-A43B8839E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DA6D18BC-1C35-495D-B152-7DAEEFEA8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051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01D9A64-D96D-47A4-BB4E-AE035F9DD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2598618-1AF3-430D-91E1-4178AED7FD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AC94EEFE-9DD7-4CEC-9541-44BC1930A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07CAD35-78E1-438C-82C8-759DBA478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B34DA5C7-3AD5-4B46-9130-D0BD2F163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1D916BD5-773C-46E6-BABF-1C8BE379D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2555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2F57871-4EB3-49CF-9B8A-15B712061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B90BD8E5-683C-4386-8F2B-6FEE963EC3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C77FD70-D2DD-4CC9-9594-99700BB67A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D007A41-E670-42B9-9B4A-E5E6A6BD8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7943BA1-0A91-45A6-9008-154F152D9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2C4C634-A640-4A5B-8526-C2439A2D7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972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C85091E0-A39D-4A67-83D4-A93F259384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01FE8412-673D-4182-9408-7647148C2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7C1F758-C973-4CFF-A188-26271A59FF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CD2B3-AC11-46ED-A58D-4687EF3BDA9B}" type="datetimeFigureOut">
              <a:rPr lang="en-GB" smtClean="0"/>
              <a:t>18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EDA8BF8-7E92-4ADE-AA71-BEB2585837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CCBBE54-2CF6-4CA5-90FC-356CECCA80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BB4A7-B596-492A-9DC4-CE45489651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491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Chart 17">
            <a:extLst>
              <a:ext uri="{FF2B5EF4-FFF2-40B4-BE49-F238E27FC236}">
                <a16:creationId xmlns="" xmlns:a16="http://schemas.microsoft.com/office/drawing/2014/main" id="{6950805E-E024-48D3-9B71-A67DD3AEB2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4816629"/>
              </p:ext>
            </p:extLst>
          </p:nvPr>
        </p:nvGraphicFramePr>
        <p:xfrm>
          <a:off x="4429102" y="674907"/>
          <a:ext cx="3832907" cy="2414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F1F1CA6F-34D8-4DB9-9672-30EA1A303B87}"/>
              </a:ext>
            </a:extLst>
          </p:cNvPr>
          <p:cNvSpPr txBox="1"/>
          <p:nvPr/>
        </p:nvSpPr>
        <p:spPr>
          <a:xfrm>
            <a:off x="5857313" y="243125"/>
            <a:ext cx="1301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cs typeface="Calibri" panose="020F0502020204030204" pitchFamily="34" charset="0"/>
              </a:rPr>
              <a:t>β</a:t>
            </a:r>
            <a:r>
              <a:rPr lang="en-GB" b="1" dirty="0" smtClean="0"/>
              <a:t>-</a:t>
            </a:r>
            <a:r>
              <a:rPr lang="en-GB" b="1" dirty="0" err="1" smtClean="0"/>
              <a:t>caro</a:t>
            </a:r>
            <a:r>
              <a:rPr lang="en-GB" b="1" dirty="0" smtClean="0"/>
              <a:t> </a:t>
            </a:r>
            <a:r>
              <a:rPr lang="en-GB" b="1" dirty="0" smtClean="0"/>
              <a:t>line</a:t>
            </a:r>
            <a:endParaRPr lang="en-GB" b="1" dirty="0"/>
          </a:p>
        </p:txBody>
      </p:sp>
      <p:graphicFrame>
        <p:nvGraphicFramePr>
          <p:cNvPr id="20" name="Chart 19">
            <a:extLst>
              <a:ext uri="{FF2B5EF4-FFF2-40B4-BE49-F238E27FC236}">
                <a16:creationId xmlns="" xmlns:a16="http://schemas.microsoft.com/office/drawing/2014/main" id="{E99D58C3-B83B-467B-8E42-51053FEF65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9529798"/>
              </p:ext>
            </p:extLst>
          </p:nvPr>
        </p:nvGraphicFramePr>
        <p:xfrm>
          <a:off x="563715" y="644590"/>
          <a:ext cx="3832907" cy="2449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6BF08009-1EF1-46E1-BD5C-EB919A968D20}"/>
              </a:ext>
            </a:extLst>
          </p:cNvPr>
          <p:cNvSpPr txBox="1"/>
          <p:nvPr/>
        </p:nvSpPr>
        <p:spPr>
          <a:xfrm>
            <a:off x="2202049" y="243125"/>
            <a:ext cx="915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Control</a:t>
            </a:r>
            <a:endParaRPr lang="en-GB" b="1" dirty="0"/>
          </a:p>
        </p:txBody>
      </p:sp>
      <p:graphicFrame>
        <p:nvGraphicFramePr>
          <p:cNvPr id="21" name="Chart 20">
            <a:extLst>
              <a:ext uri="{FF2B5EF4-FFF2-40B4-BE49-F238E27FC236}">
                <a16:creationId xmlns="" xmlns:a16="http://schemas.microsoft.com/office/drawing/2014/main" id="{F10B270D-BD59-4030-948D-E78AA66484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1531877"/>
              </p:ext>
            </p:extLst>
          </p:nvPr>
        </p:nvGraphicFramePr>
        <p:xfrm>
          <a:off x="8148805" y="674907"/>
          <a:ext cx="3979579" cy="2449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F1F1CA6F-34D8-4DB9-9672-30EA1A303B87}"/>
              </a:ext>
            </a:extLst>
          </p:cNvPr>
          <p:cNvSpPr txBox="1"/>
          <p:nvPr/>
        </p:nvSpPr>
        <p:spPr>
          <a:xfrm>
            <a:off x="9860644" y="243125"/>
            <a:ext cx="1301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smtClean="0">
                <a:cs typeface="Calibri" panose="020F0502020204030204" pitchFamily="34" charset="0"/>
              </a:rPr>
              <a:t>Keto</a:t>
            </a:r>
            <a:r>
              <a:rPr lang="en-GB" b="1" smtClean="0"/>
              <a:t> </a:t>
            </a:r>
            <a:r>
              <a:rPr lang="en-GB" b="1" dirty="0" smtClean="0"/>
              <a:t>line</a:t>
            </a:r>
            <a:endParaRPr lang="en-GB" b="1" dirty="0"/>
          </a:p>
        </p:txBody>
      </p:sp>
      <p:cxnSp>
        <p:nvCxnSpPr>
          <p:cNvPr id="3" name="Straight Connector 2"/>
          <p:cNvCxnSpPr/>
          <p:nvPr/>
        </p:nvCxnSpPr>
        <p:spPr>
          <a:xfrm flipV="1">
            <a:off x="1363762" y="3443369"/>
            <a:ext cx="720000" cy="0"/>
          </a:xfrm>
          <a:prstGeom prst="line">
            <a:avLst/>
          </a:prstGeom>
          <a:ln w="3810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6BF08009-1EF1-46E1-BD5C-EB919A968D20}"/>
              </a:ext>
            </a:extLst>
          </p:cNvPr>
          <p:cNvSpPr txBox="1"/>
          <p:nvPr/>
        </p:nvSpPr>
        <p:spPr>
          <a:xfrm>
            <a:off x="2108873" y="3252807"/>
            <a:ext cx="2086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yclic carotenoids</a:t>
            </a:r>
            <a:endParaRPr lang="en-GB" dirty="0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4165292" y="3444241"/>
            <a:ext cx="720000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6BF08009-1EF1-46E1-BD5C-EB919A968D20}"/>
              </a:ext>
            </a:extLst>
          </p:cNvPr>
          <p:cNvSpPr txBox="1"/>
          <p:nvPr/>
        </p:nvSpPr>
        <p:spPr>
          <a:xfrm>
            <a:off x="4910402" y="3253679"/>
            <a:ext cx="2477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ree ketocarotenoids</a:t>
            </a:r>
            <a:endParaRPr lang="en-GB" dirty="0"/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7316907" y="3445116"/>
            <a:ext cx="720000" cy="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6BF08009-1EF1-46E1-BD5C-EB919A968D20}"/>
              </a:ext>
            </a:extLst>
          </p:cNvPr>
          <p:cNvSpPr txBox="1"/>
          <p:nvPr/>
        </p:nvSpPr>
        <p:spPr>
          <a:xfrm>
            <a:off x="8062017" y="3254554"/>
            <a:ext cx="3334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sterified ketocarotenoids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-1049652" y="1075173"/>
            <a:ext cx="26961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% of </a:t>
            </a:r>
            <a:r>
              <a:rPr lang="en-GB" dirty="0"/>
              <a:t>µ</a:t>
            </a:r>
            <a:r>
              <a:rPr lang="en-GB" dirty="0" smtClean="0"/>
              <a:t>g/ fraction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8499656" y="2405665"/>
            <a:ext cx="394252" cy="40233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10156" t="72982" r="81740" b="12552"/>
          <a:stretch/>
        </p:blipFill>
        <p:spPr>
          <a:xfrm>
            <a:off x="8798272" y="1053338"/>
            <a:ext cx="775466" cy="8530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9" name="Straight Connector 8"/>
          <p:cNvCxnSpPr/>
          <p:nvPr/>
        </p:nvCxnSpPr>
        <p:spPr>
          <a:xfrm flipV="1">
            <a:off x="8511946" y="1916227"/>
            <a:ext cx="273747" cy="478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9036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</dc:creator>
  <cp:lastModifiedBy>marilise nogueira</cp:lastModifiedBy>
  <cp:revision>11</cp:revision>
  <dcterms:created xsi:type="dcterms:W3CDTF">2021-09-22T14:06:07Z</dcterms:created>
  <dcterms:modified xsi:type="dcterms:W3CDTF">2022-10-18T13:32:24Z</dcterms:modified>
</cp:coreProperties>
</file>